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1" autoAdjust="0"/>
    <p:restoredTop sz="94660"/>
  </p:normalViewPr>
  <p:slideViewPr>
    <p:cSldViewPr snapToGrid="0">
      <p:cViewPr varScale="1">
        <p:scale>
          <a:sx n="102" d="100"/>
          <a:sy n="102" d="100"/>
        </p:scale>
        <p:origin x="-114" y="-36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281919-416E-4C63-B5FA-C141FBB06A42}" type="datetimeFigureOut">
              <a:rPr lang="en-GB" smtClean="0"/>
              <a:t>15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BB57A-2082-4AF2-892A-283B4EE38C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23262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281919-416E-4C63-B5FA-C141FBB06A42}" type="datetimeFigureOut">
              <a:rPr lang="en-GB" smtClean="0"/>
              <a:t>15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BB57A-2082-4AF2-892A-283B4EE38C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52555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281919-416E-4C63-B5FA-C141FBB06A42}" type="datetimeFigureOut">
              <a:rPr lang="en-GB" smtClean="0"/>
              <a:t>15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BB57A-2082-4AF2-892A-283B4EE38C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97761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281919-416E-4C63-B5FA-C141FBB06A42}" type="datetimeFigureOut">
              <a:rPr lang="en-GB" smtClean="0"/>
              <a:t>15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BB57A-2082-4AF2-892A-283B4EE38C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35063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281919-416E-4C63-B5FA-C141FBB06A42}" type="datetimeFigureOut">
              <a:rPr lang="en-GB" smtClean="0"/>
              <a:t>15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BB57A-2082-4AF2-892A-283B4EE38C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64397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281919-416E-4C63-B5FA-C141FBB06A42}" type="datetimeFigureOut">
              <a:rPr lang="en-GB" smtClean="0"/>
              <a:t>15/1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BB57A-2082-4AF2-892A-283B4EE38C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10838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281919-416E-4C63-B5FA-C141FBB06A42}" type="datetimeFigureOut">
              <a:rPr lang="en-GB" smtClean="0"/>
              <a:t>15/11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BB57A-2082-4AF2-892A-283B4EE38C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5970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281919-416E-4C63-B5FA-C141FBB06A42}" type="datetimeFigureOut">
              <a:rPr lang="en-GB" smtClean="0"/>
              <a:t>15/11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BB57A-2082-4AF2-892A-283B4EE38C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2437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281919-416E-4C63-B5FA-C141FBB06A42}" type="datetimeFigureOut">
              <a:rPr lang="en-GB" smtClean="0"/>
              <a:t>15/11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BB57A-2082-4AF2-892A-283B4EE38C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53028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281919-416E-4C63-B5FA-C141FBB06A42}" type="datetimeFigureOut">
              <a:rPr lang="en-GB" smtClean="0"/>
              <a:t>15/1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BB57A-2082-4AF2-892A-283B4EE38C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3214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281919-416E-4C63-B5FA-C141FBB06A42}" type="datetimeFigureOut">
              <a:rPr lang="en-GB" smtClean="0"/>
              <a:t>15/1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BB57A-2082-4AF2-892A-283B4EE38C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52114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281919-416E-4C63-B5FA-C141FBB06A42}" type="datetimeFigureOut">
              <a:rPr lang="en-GB" smtClean="0"/>
              <a:t>15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DBB57A-2082-4AF2-892A-283B4EE38C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9573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7025" y="0"/>
            <a:ext cx="6853850" cy="6858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8486775" y="1114425"/>
            <a:ext cx="3486150" cy="35394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u="sng" dirty="0"/>
              <a:t>Additional File </a:t>
            </a:r>
            <a:r>
              <a:rPr lang="en-GB" sz="1600" u="sng" dirty="0" smtClean="0"/>
              <a:t>12 </a:t>
            </a:r>
            <a:r>
              <a:rPr lang="en-GB" sz="1600" dirty="0"/>
              <a:t>Protein interaction networks associated with mouse germ cell-specific transcripts using the STRING database. Each circle represents a protein (node) and each line (edge) represents a protein-protein association.  Only nodes which are connected are shown. The line colour and thickness indicate the type of interaction evidence and the strength of data support. A combination score &gt;0.4 was set as the reliability threshold for network construction. The network contains 1915 nodes and 5542 edges.</a:t>
            </a:r>
          </a:p>
        </p:txBody>
      </p:sp>
    </p:spTree>
    <p:extLst>
      <p:ext uri="{BB962C8B-B14F-4D97-AF65-F5344CB8AC3E}">
        <p14:creationId xmlns:p14="http://schemas.microsoft.com/office/powerpoint/2010/main" val="13695178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6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ter O'Shaughnessy</dc:creator>
  <cp:lastModifiedBy>pos1u</cp:lastModifiedBy>
  <cp:revision>2</cp:revision>
  <dcterms:created xsi:type="dcterms:W3CDTF">2017-08-08T12:36:22Z</dcterms:created>
  <dcterms:modified xsi:type="dcterms:W3CDTF">2017-11-15T14:55:17Z</dcterms:modified>
</cp:coreProperties>
</file>